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-48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053663652"/>
              </p:ext>
            </p:extLst>
          </p:nvPr>
        </p:nvGraphicFramePr>
        <p:xfrm>
          <a:off x="91957" y="1331549"/>
          <a:ext cx="12843746" cy="123636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61006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315116">
                  <a:extLst>
                    <a:ext uri="{9D8B030D-6E8A-4147-A177-3AD203B41FA5}">
                      <a16:colId xmlns:a16="http://schemas.microsoft.com/office/drawing/2014/main" xmlns="" val="2513535775"/>
                    </a:ext>
                  </a:extLst>
                </a:gridCol>
                <a:gridCol w="862428">
                  <a:extLst>
                    <a:ext uri="{9D8B030D-6E8A-4147-A177-3AD203B41FA5}">
                      <a16:colId xmlns:a16="http://schemas.microsoft.com/office/drawing/2014/main" xmlns="" val="600053052"/>
                    </a:ext>
                  </a:extLst>
                </a:gridCol>
                <a:gridCol w="1133856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448838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-1994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78486074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8 [3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3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6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7; 1.05]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incent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2 [64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84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853790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7; 0.21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8944288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hu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5]  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9; 3.05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50794679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amaguch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6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8; 1.6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62126362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ijhof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63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4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an't Leve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0 [68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0; 1.21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5293092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58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78994920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26; 2.06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138126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8 [70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1; 0.4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43389006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8 [7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 1.1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8963373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eves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2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7; 2.4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5289956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jok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5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86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7242282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im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8; 1.27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55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437475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rberg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5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9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30; 3.2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03153161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vangard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6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40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17; 2.5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46927803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Yi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7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5.0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18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7721321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uiber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8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15; 4.16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6063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on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8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3; 0.49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arm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8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71; 3.32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0720658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ald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8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4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3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9107548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y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54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5; 0.8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10182719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cCaule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8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2; 3.5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23522958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4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8226694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3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69; 2.14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3586543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3; 2.89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342582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85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02; 3.51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58115011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53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7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5; 0.5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74072927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9; 1.5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48131884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teele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2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6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7165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kuda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88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4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65; 4.44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068559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0; 3.44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36350838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owa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elosi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6 [90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5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 0.66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62505575"/>
                  </a:ext>
                </a:extLst>
              </a:tr>
              <a:tr h="382540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8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; 1.1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81354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4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4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s </a:t>
                      </a:r>
                      <a:r>
                        <a:rPr lang="en-US" altLang="ko-KR" sz="14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; 1.3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10637798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9.1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1.3691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E6ABCF5D-6227-477D-A84F-866680B7F045}"/>
              </a:ext>
            </a:extLst>
          </p:cNvPr>
          <p:cNvSpPr txBox="1"/>
          <p:nvPr/>
        </p:nvSpPr>
        <p:spPr>
          <a:xfrm>
            <a:off x="91957" y="968749"/>
            <a:ext cx="1035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CFS/ME prevalence based on the CDC-1994 case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inition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4299186" y="2031563"/>
            <a:ext cx="5711131" cy="11477299"/>
            <a:chOff x="4319136" y="2031563"/>
            <a:chExt cx="5711131" cy="11477299"/>
          </a:xfrm>
        </p:grpSpPr>
        <p:grpSp>
          <p:nvGrpSpPr>
            <p:cNvPr id="18" name="그룹 17"/>
            <p:cNvGrpSpPr/>
            <p:nvPr/>
          </p:nvGrpSpPr>
          <p:grpSpPr>
            <a:xfrm>
              <a:off x="4319136" y="13057073"/>
              <a:ext cx="5711131" cy="451789"/>
              <a:chOff x="4081382" y="14247381"/>
              <a:chExt cx="6452506" cy="451789"/>
            </a:xfrm>
          </p:grpSpPr>
          <p:pic>
            <p:nvPicPr>
              <p:cNvPr id="20" name="그림 19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161550" y="14247381"/>
                <a:ext cx="5506913" cy="206392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4081382" y="14380621"/>
                <a:ext cx="6452506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1.0      2.0      3.0       4.0      5.0      6.0      7.0      8.0     9.0 (%) 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31800" y="2031563"/>
              <a:ext cx="4817518" cy="108757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xmlns="" val="3295647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687</Words>
  <Application>Microsoft Office PowerPoint</Application>
  <PresentationFormat>Custom</PresentationFormat>
  <Paragraphs>3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5:44Z</dcterms:modified>
</cp:coreProperties>
</file>